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3" r:id="rId3"/>
    <p:sldId id="261" r:id="rId4"/>
    <p:sldId id="258" r:id="rId5"/>
    <p:sldId id="259" r:id="rId6"/>
    <p:sldId id="25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75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961204-78E4-6F67-54E0-52DE8D1649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DEB707A-2600-A414-82DC-7F503D6EC7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9B26F3-4FF8-152B-1CF8-B250BC5DE8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5A0BA-C019-4AF4-81D2-43966F36165F}" type="datetimeFigureOut">
              <a:rPr lang="en-US" smtClean="0"/>
              <a:t>11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D0E279-D817-44E1-1453-0FA6BA0ECB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6F7928-32B9-C666-8EA3-773E761A9F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93C0-225E-4475-9FAD-461D430D6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648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CA7C31-5F2E-8E62-9F44-DDEE60A411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5F6A35-61C4-F603-8ECE-C754AAE31C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909987-E5A4-ABB0-DFC2-EEDEF409B2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5A0BA-C019-4AF4-81D2-43966F36165F}" type="datetimeFigureOut">
              <a:rPr lang="en-US" smtClean="0"/>
              <a:t>11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236B01-365D-404B-F256-F63B40B5D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00732C-0339-7091-A315-5B4448814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93C0-225E-4475-9FAD-461D430D6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927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4FE60A6-A307-F190-5EF2-4510343A41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57113A-A9B0-91E2-F84B-C2F105148C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C55DCD-3772-FF42-A620-CFF2B9AA15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5A0BA-C019-4AF4-81D2-43966F36165F}" type="datetimeFigureOut">
              <a:rPr lang="en-US" smtClean="0"/>
              <a:t>11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20674A-2E31-E872-6605-C975E4D0E0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6087D5-91C3-DE0A-1DCE-E47D961DB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93C0-225E-4475-9FAD-461D430D6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44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5A6BB6-E115-D91D-1CDE-3936566D71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EC2EC8-55F1-CB3C-8749-9A08BA0177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EDF7B6-B5B4-C391-C1B2-479DB0CD3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5A0BA-C019-4AF4-81D2-43966F36165F}" type="datetimeFigureOut">
              <a:rPr lang="en-US" smtClean="0"/>
              <a:t>11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6C1D2C-A803-405C-A1E7-11875C389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10F5ED-2034-8E63-1890-57E16107D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93C0-225E-4475-9FAD-461D430D6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883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2814D5-BDD4-5296-7D34-85437F6381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5A4D4A-A3DF-DF9C-E84A-E4CCA2AE5A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A393D9-C541-40C9-71CF-D3A2E88CAB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5A0BA-C019-4AF4-81D2-43966F36165F}" type="datetimeFigureOut">
              <a:rPr lang="en-US" smtClean="0"/>
              <a:t>11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6C3E3C-9CCF-AFE0-C037-3BEE0D5153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58671E-6692-4927-9136-AD6FA16BE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93C0-225E-4475-9FAD-461D430D6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981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AF3263-0E9F-B8A3-2CE4-60431747D9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C7C0AD-603B-15BC-9B17-6F43ECECD1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5322DC-9842-F61C-5DE4-2BC428068E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72E6D3-EDDA-34BF-17ED-584A40E29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5A0BA-C019-4AF4-81D2-43966F36165F}" type="datetimeFigureOut">
              <a:rPr lang="en-US" smtClean="0"/>
              <a:t>11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B15BA2-D474-06EF-B08A-6E3C64429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66BF87-C8F7-0598-69DD-C7FF5DE44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93C0-225E-4475-9FAD-461D430D6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033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D75BED-A78E-A617-F444-295E496A60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042F74-0048-004E-EDEB-EE0372EDEC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3547C0-6D28-A63B-30D8-E96374440A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957E548-6AE1-FFF9-6D0B-7B3D721E98B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B6AD86-CBA7-4C9C-E0C1-CD1E8CA0E7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5B12DA-AE78-7F60-CDA7-FABD99015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5A0BA-C019-4AF4-81D2-43966F36165F}" type="datetimeFigureOut">
              <a:rPr lang="en-US" smtClean="0"/>
              <a:t>11/1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900052-608A-E943-A374-6AD43C230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FE91BF0-0E52-09EA-7961-853CB57E9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93C0-225E-4475-9FAD-461D430D6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497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21E560-943E-CC23-98D3-D7899A5FA3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9DC7D8-AC5E-1A02-2FAD-7E39ED92E7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5A0BA-C019-4AF4-81D2-43966F36165F}" type="datetimeFigureOut">
              <a:rPr lang="en-US" smtClean="0"/>
              <a:t>11/1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1AF540A-3CAE-A67D-F4FE-151163C28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4436328-5EF3-981A-AA1E-849D2DCFA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93C0-225E-4475-9FAD-461D430D6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340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E993C75-A2A2-493F-7C73-40F222F4A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5A0BA-C019-4AF4-81D2-43966F36165F}" type="datetimeFigureOut">
              <a:rPr lang="en-US" smtClean="0"/>
              <a:t>11/1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89A33D1-7421-56D3-48F8-5AF4BEC79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03F9EB-58F6-4E89-1D0D-A71606F7F6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93C0-225E-4475-9FAD-461D430D6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195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90CB3E-5503-9B2A-7735-D4EC12235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B61632-5E3D-AF28-3211-24C2D38DFE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63BA95-C98A-97AC-7028-39CFD8869E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B02273-19C0-99B6-8DBF-11A97D5FAE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5A0BA-C019-4AF4-81D2-43966F36165F}" type="datetimeFigureOut">
              <a:rPr lang="en-US" smtClean="0"/>
              <a:t>11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812165-69AD-B369-33B2-015DD27BA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7A74FA-40C1-0001-2D71-DFD92AF88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93C0-225E-4475-9FAD-461D430D6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555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58ABF8-AB5E-A3A0-C43A-0A22D88194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19FC6E-27C7-62BF-43AD-1A1B443D65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71A70B-D94E-A540-6E43-84C49F8B4E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74BDEA-6A7D-14AB-7AA8-E34ACECC6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5A0BA-C019-4AF4-81D2-43966F36165F}" type="datetimeFigureOut">
              <a:rPr lang="en-US" smtClean="0"/>
              <a:t>11/1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D698E1-0470-C679-9B80-FD4752CF4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BA3F7C-9539-6307-B8CA-C7DDA7695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393C0-225E-4475-9FAD-461D430D6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8528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845F829-4692-DB38-84FD-D2E30429C8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AD48-1D44-1618-9890-9E40673C3C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FF791F-D02E-8711-C21F-6581D8872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535A0BA-C019-4AF4-81D2-43966F36165F}" type="datetimeFigureOut">
              <a:rPr lang="en-US" smtClean="0"/>
              <a:t>11/1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D13BB3-B49D-8C29-5F29-4D0C8C2970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98F307-7D64-CC54-113B-CDA421A727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1393C0-225E-4475-9FAD-461D430D61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871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BCB69CB-9DAE-D247-499B-17A47E871D38}"/>
              </a:ext>
            </a:extLst>
          </p:cNvPr>
          <p:cNvSpPr txBox="1"/>
          <p:nvPr/>
        </p:nvSpPr>
        <p:spPr>
          <a:xfrm>
            <a:off x="282804" y="454727"/>
            <a:ext cx="115666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Table S1. </a:t>
            </a:r>
            <a:r>
              <a:rPr lang="en-US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ody temperature in sheep following primary and booster vaccination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160BC00B-137A-8CFD-F3EA-70C9887274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033349"/>
              </p:ext>
            </p:extLst>
          </p:nvPr>
        </p:nvGraphicFramePr>
        <p:xfrm>
          <a:off x="216815" y="1141001"/>
          <a:ext cx="11312167" cy="5163480"/>
        </p:xfrm>
        <a:graphic>
          <a:graphicData uri="http://schemas.openxmlformats.org/drawingml/2006/table">
            <a:tbl>
              <a:tblPr firstRow="1" bandRow="1">
                <a:tableStyleId>{93296810-A885-4BE3-A3E7-6D5BEEA58F35}</a:tableStyleId>
              </a:tblPr>
              <a:tblGrid>
                <a:gridCol w="1432206">
                  <a:extLst>
                    <a:ext uri="{9D8B030D-6E8A-4147-A177-3AD203B41FA5}">
                      <a16:colId xmlns:a16="http://schemas.microsoft.com/office/drawing/2014/main" val="2026479519"/>
                    </a:ext>
                  </a:extLst>
                </a:gridCol>
                <a:gridCol w="943439">
                  <a:extLst>
                    <a:ext uri="{9D8B030D-6E8A-4147-A177-3AD203B41FA5}">
                      <a16:colId xmlns:a16="http://schemas.microsoft.com/office/drawing/2014/main" val="1209624767"/>
                    </a:ext>
                  </a:extLst>
                </a:gridCol>
                <a:gridCol w="813858">
                  <a:extLst>
                    <a:ext uri="{9D8B030D-6E8A-4147-A177-3AD203B41FA5}">
                      <a16:colId xmlns:a16="http://schemas.microsoft.com/office/drawing/2014/main" val="517178066"/>
                    </a:ext>
                  </a:extLst>
                </a:gridCol>
                <a:gridCol w="846821">
                  <a:extLst>
                    <a:ext uri="{9D8B030D-6E8A-4147-A177-3AD203B41FA5}">
                      <a16:colId xmlns:a16="http://schemas.microsoft.com/office/drawing/2014/main" val="47049532"/>
                    </a:ext>
                  </a:extLst>
                </a:gridCol>
                <a:gridCol w="846821">
                  <a:extLst>
                    <a:ext uri="{9D8B030D-6E8A-4147-A177-3AD203B41FA5}">
                      <a16:colId xmlns:a16="http://schemas.microsoft.com/office/drawing/2014/main" val="2804280217"/>
                    </a:ext>
                  </a:extLst>
                </a:gridCol>
                <a:gridCol w="911611">
                  <a:extLst>
                    <a:ext uri="{9D8B030D-6E8A-4147-A177-3AD203B41FA5}">
                      <a16:colId xmlns:a16="http://schemas.microsoft.com/office/drawing/2014/main" val="2226751008"/>
                    </a:ext>
                  </a:extLst>
                </a:gridCol>
                <a:gridCol w="918432">
                  <a:extLst>
                    <a:ext uri="{9D8B030D-6E8A-4147-A177-3AD203B41FA5}">
                      <a16:colId xmlns:a16="http://schemas.microsoft.com/office/drawing/2014/main" val="782913579"/>
                    </a:ext>
                  </a:extLst>
                </a:gridCol>
                <a:gridCol w="918432">
                  <a:extLst>
                    <a:ext uri="{9D8B030D-6E8A-4147-A177-3AD203B41FA5}">
                      <a16:colId xmlns:a16="http://schemas.microsoft.com/office/drawing/2014/main" val="2330148305"/>
                    </a:ext>
                  </a:extLst>
                </a:gridCol>
                <a:gridCol w="918432">
                  <a:extLst>
                    <a:ext uri="{9D8B030D-6E8A-4147-A177-3AD203B41FA5}">
                      <a16:colId xmlns:a16="http://schemas.microsoft.com/office/drawing/2014/main" val="2612047918"/>
                    </a:ext>
                  </a:extLst>
                </a:gridCol>
                <a:gridCol w="920705">
                  <a:extLst>
                    <a:ext uri="{9D8B030D-6E8A-4147-A177-3AD203B41FA5}">
                      <a16:colId xmlns:a16="http://schemas.microsoft.com/office/drawing/2014/main" val="1774006700"/>
                    </a:ext>
                  </a:extLst>
                </a:gridCol>
                <a:gridCol w="920705">
                  <a:extLst>
                    <a:ext uri="{9D8B030D-6E8A-4147-A177-3AD203B41FA5}">
                      <a16:colId xmlns:a16="http://schemas.microsoft.com/office/drawing/2014/main" val="4278547435"/>
                    </a:ext>
                  </a:extLst>
                </a:gridCol>
                <a:gridCol w="920705">
                  <a:extLst>
                    <a:ext uri="{9D8B030D-6E8A-4147-A177-3AD203B41FA5}">
                      <a16:colId xmlns:a16="http://schemas.microsoft.com/office/drawing/2014/main" val="1093351125"/>
                    </a:ext>
                  </a:extLst>
                </a:gridCol>
              </a:tblGrid>
              <a:tr h="258174"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</a:t>
                      </a:r>
                      <a:r>
                        <a:rPr lang="en-US" sz="1000" kern="100" cap="all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gridSpan="10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eep body temperature in ℃  (day-post vaccination)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1275492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0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3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6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7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14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21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29*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32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36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45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31103755"/>
                  </a:ext>
                </a:extLst>
              </a:tr>
              <a:tr h="258174">
                <a:tc rowSpan="6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HV-1qmv vector control group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6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1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16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8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8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389768660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2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6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8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2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07246519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94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2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47635973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44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2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2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94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553341288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16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22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3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660364270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7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05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2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8</a:t>
                      </a:r>
                      <a:endParaRPr lang="en-US" sz="10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4</a:t>
                      </a:r>
                      <a:endParaRPr lang="en-US" sz="10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3</a:t>
                      </a:r>
                      <a:endParaRPr lang="en-US" sz="1000" b="1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4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99074060"/>
                  </a:ext>
                </a:extLst>
              </a:tr>
              <a:tr h="258174">
                <a:tc rowSpan="6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7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33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6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2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35031505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33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2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7</a:t>
                      </a:r>
                      <a:endParaRPr lang="en-US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596181082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1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0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125283020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2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60284032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1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2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5032940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1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45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1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1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94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7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2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6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1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9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28466950"/>
                  </a:ext>
                </a:extLst>
              </a:tr>
              <a:tr h="258174">
                <a:tc rowSpan="6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-Boost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2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94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90113275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44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8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3610663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2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94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8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8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38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34699268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3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61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8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1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16326496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6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44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2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8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7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5</a:t>
                      </a:r>
                      <a:endParaRPr lang="en-US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02194103"/>
                  </a:ext>
                </a:extLst>
              </a:tr>
              <a:tr h="25817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8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02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43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98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1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51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91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78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3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5</a:t>
                      </a:r>
                      <a:endParaRPr lang="en-US" sz="10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406649080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1E490E3A-2062-EBF2-C48A-104D27ABE126}"/>
              </a:ext>
            </a:extLst>
          </p:cNvPr>
          <p:cNvSpPr txBox="1"/>
          <p:nvPr/>
        </p:nvSpPr>
        <p:spPr>
          <a:xfrm>
            <a:off x="3758184" y="6336792"/>
            <a:ext cx="34660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*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oster immunization performed on day 29 post-vaccination</a:t>
            </a:r>
          </a:p>
        </p:txBody>
      </p:sp>
    </p:spTree>
    <p:extLst>
      <p:ext uri="{BB962C8B-B14F-4D97-AF65-F5344CB8AC3E}">
        <p14:creationId xmlns:p14="http://schemas.microsoft.com/office/powerpoint/2010/main" val="39774299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873A66D-B5AC-FF32-466D-FE1CF73D7A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5569382"/>
              </p:ext>
            </p:extLst>
          </p:nvPr>
        </p:nvGraphicFramePr>
        <p:xfrm>
          <a:off x="455797" y="1244281"/>
          <a:ext cx="11583803" cy="5039974"/>
        </p:xfrm>
        <a:graphic>
          <a:graphicData uri="http://schemas.openxmlformats.org/drawingml/2006/table">
            <a:tbl>
              <a:tblPr firstRow="1" bandRow="1">
                <a:tableStyleId>{93296810-A885-4BE3-A3E7-6D5BEEA58F35}</a:tableStyleId>
              </a:tblPr>
              <a:tblGrid>
                <a:gridCol w="1375777">
                  <a:extLst>
                    <a:ext uri="{9D8B030D-6E8A-4147-A177-3AD203B41FA5}">
                      <a16:colId xmlns:a16="http://schemas.microsoft.com/office/drawing/2014/main" val="4062396620"/>
                    </a:ext>
                  </a:extLst>
                </a:gridCol>
                <a:gridCol w="928281">
                  <a:extLst>
                    <a:ext uri="{9D8B030D-6E8A-4147-A177-3AD203B41FA5}">
                      <a16:colId xmlns:a16="http://schemas.microsoft.com/office/drawing/2014/main" val="3576248032"/>
                    </a:ext>
                  </a:extLst>
                </a:gridCol>
                <a:gridCol w="1234603">
                  <a:extLst>
                    <a:ext uri="{9D8B030D-6E8A-4147-A177-3AD203B41FA5}">
                      <a16:colId xmlns:a16="http://schemas.microsoft.com/office/drawing/2014/main" val="3240269520"/>
                    </a:ext>
                  </a:extLst>
                </a:gridCol>
                <a:gridCol w="1234603">
                  <a:extLst>
                    <a:ext uri="{9D8B030D-6E8A-4147-A177-3AD203B41FA5}">
                      <a16:colId xmlns:a16="http://schemas.microsoft.com/office/drawing/2014/main" val="1340461928"/>
                    </a:ext>
                  </a:extLst>
                </a:gridCol>
                <a:gridCol w="1160691">
                  <a:extLst>
                    <a:ext uri="{9D8B030D-6E8A-4147-A177-3AD203B41FA5}">
                      <a16:colId xmlns:a16="http://schemas.microsoft.com/office/drawing/2014/main" val="4119006938"/>
                    </a:ext>
                  </a:extLst>
                </a:gridCol>
                <a:gridCol w="988608">
                  <a:extLst>
                    <a:ext uri="{9D8B030D-6E8A-4147-A177-3AD203B41FA5}">
                      <a16:colId xmlns:a16="http://schemas.microsoft.com/office/drawing/2014/main" val="3786108497"/>
                    </a:ext>
                  </a:extLst>
                </a:gridCol>
                <a:gridCol w="722978">
                  <a:extLst>
                    <a:ext uri="{9D8B030D-6E8A-4147-A177-3AD203B41FA5}">
                      <a16:colId xmlns:a16="http://schemas.microsoft.com/office/drawing/2014/main" val="321007928"/>
                    </a:ext>
                  </a:extLst>
                </a:gridCol>
                <a:gridCol w="773793">
                  <a:extLst>
                    <a:ext uri="{9D8B030D-6E8A-4147-A177-3AD203B41FA5}">
                      <a16:colId xmlns:a16="http://schemas.microsoft.com/office/drawing/2014/main" val="1983402410"/>
                    </a:ext>
                  </a:extLst>
                </a:gridCol>
                <a:gridCol w="837314">
                  <a:extLst>
                    <a:ext uri="{9D8B030D-6E8A-4147-A177-3AD203B41FA5}">
                      <a16:colId xmlns:a16="http://schemas.microsoft.com/office/drawing/2014/main" val="3493543906"/>
                    </a:ext>
                  </a:extLst>
                </a:gridCol>
                <a:gridCol w="837314">
                  <a:extLst>
                    <a:ext uri="{9D8B030D-6E8A-4147-A177-3AD203B41FA5}">
                      <a16:colId xmlns:a16="http://schemas.microsoft.com/office/drawing/2014/main" val="158890568"/>
                    </a:ext>
                  </a:extLst>
                </a:gridCol>
                <a:gridCol w="770328">
                  <a:extLst>
                    <a:ext uri="{9D8B030D-6E8A-4147-A177-3AD203B41FA5}">
                      <a16:colId xmlns:a16="http://schemas.microsoft.com/office/drawing/2014/main" val="952431494"/>
                    </a:ext>
                  </a:extLst>
                </a:gridCol>
                <a:gridCol w="719513">
                  <a:extLst>
                    <a:ext uri="{9D8B030D-6E8A-4147-A177-3AD203B41FA5}">
                      <a16:colId xmlns:a16="http://schemas.microsoft.com/office/drawing/2014/main" val="2245223441"/>
                    </a:ext>
                  </a:extLst>
                </a:gridCol>
              </a:tblGrid>
              <a:tr h="34147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cap="all" dirty="0">
                          <a:effectLst/>
                        </a:rPr>
                        <a:t>Group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Animal </a:t>
                      </a:r>
                      <a:r>
                        <a:rPr lang="en-US" sz="1400" kern="1200" cap="all" dirty="0">
                          <a:effectLst/>
                        </a:rPr>
                        <a:t>#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gridSpan="10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Nasal virus shedding following primary (day 0) and booster immunization (day 29) – BoHV-1 genome copies/nasal swab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20852832"/>
                  </a:ext>
                </a:extLst>
              </a:tr>
              <a:tr h="234228">
                <a:tc>
                  <a:txBody>
                    <a:bodyPr/>
                    <a:lstStyle/>
                    <a:p>
                      <a:endParaRPr lang="en-US" sz="1400" kern="100">
                        <a:effectLst/>
                        <a:highlight>
                          <a:srgbClr val="F2F2F2"/>
                        </a:highlight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endParaRPr lang="en-US" sz="14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Day 0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Day 3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Day 6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Day 7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Day 14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Day 21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Day 29</a:t>
                      </a:r>
                      <a:r>
                        <a:rPr lang="en-US" sz="1400" b="1" kern="1200" dirty="0">
                          <a:solidFill>
                            <a:srgbClr val="FF0000"/>
                          </a:solidFill>
                          <a:effectLst/>
                        </a:rPr>
                        <a:t>*</a:t>
                      </a:r>
                      <a:endParaRPr lang="en-US" sz="1400" b="1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Day 32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Day 36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Day 45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07189544"/>
                  </a:ext>
                </a:extLst>
              </a:tr>
              <a:tr h="256390">
                <a:tc rowSpan="6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 err="1">
                          <a:effectLst/>
                        </a:rPr>
                        <a:t>qmv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41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25,034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341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489242132"/>
                  </a:ext>
                </a:extLst>
              </a:tr>
              <a:tr h="256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42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15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134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117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77857119"/>
                  </a:ext>
                </a:extLst>
              </a:tr>
              <a:tr h="256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43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208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4332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999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896245150"/>
                  </a:ext>
                </a:extLst>
              </a:tr>
              <a:tr h="2706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44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255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862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439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77068468"/>
                  </a:ext>
                </a:extLst>
              </a:tr>
              <a:tr h="256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5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563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283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04670874"/>
                  </a:ext>
                </a:extLst>
              </a:tr>
              <a:tr h="29912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Average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0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5616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1190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311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0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0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0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0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0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>
                          <a:effectLst/>
                        </a:rPr>
                        <a:t>0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57701260"/>
                  </a:ext>
                </a:extLst>
              </a:tr>
              <a:tr h="256390">
                <a:tc rowSpan="1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kern="1200" dirty="0" err="1">
                          <a:effectLst/>
                        </a:rPr>
                        <a:t>qmv</a:t>
                      </a:r>
                      <a:r>
                        <a:rPr lang="en-US" sz="1400" b="1" kern="1200" dirty="0">
                          <a:effectLst/>
                        </a:rPr>
                        <a:t> Sub-RVFV</a:t>
                      </a:r>
                      <a:endParaRPr lang="en-US" sz="1400" b="1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36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188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1029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744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374194355"/>
                  </a:ext>
                </a:extLst>
              </a:tr>
              <a:tr h="256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37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882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117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87190789"/>
                  </a:ext>
                </a:extLst>
              </a:tr>
              <a:tr h="256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38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644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567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83189505"/>
                  </a:ext>
                </a:extLst>
              </a:tr>
              <a:tr h="256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39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76,114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285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19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769711677"/>
                  </a:ext>
                </a:extLst>
              </a:tr>
              <a:tr h="256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4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2136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195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627573310"/>
                  </a:ext>
                </a:extLst>
              </a:tr>
              <a:tr h="256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45</a:t>
                      </a:r>
                      <a:r>
                        <a:rPr lang="en-US" sz="1400" kern="1200" dirty="0">
                          <a:solidFill>
                            <a:srgbClr val="FF0000"/>
                          </a:solidFill>
                          <a:effectLst/>
                        </a:rPr>
                        <a:t>*</a:t>
                      </a:r>
                      <a:endParaRPr lang="en-US" sz="14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632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883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561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265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33729238"/>
                  </a:ext>
                </a:extLst>
              </a:tr>
              <a:tr h="3050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46</a:t>
                      </a:r>
                      <a:r>
                        <a:rPr lang="en-US" sz="1400" kern="1200" dirty="0">
                          <a:solidFill>
                            <a:srgbClr val="FF0000"/>
                          </a:solidFill>
                          <a:effectLst/>
                        </a:rPr>
                        <a:t>*</a:t>
                      </a:r>
                      <a:endParaRPr lang="en-US" sz="14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3716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1597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1033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1494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1077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72512530"/>
                  </a:ext>
                </a:extLst>
              </a:tr>
              <a:tr h="256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47</a:t>
                      </a:r>
                      <a:r>
                        <a:rPr lang="en-US" sz="1400" kern="1200" dirty="0">
                          <a:solidFill>
                            <a:srgbClr val="FF0000"/>
                          </a:solidFill>
                          <a:effectLst/>
                        </a:rPr>
                        <a:t>*</a:t>
                      </a:r>
                      <a:endParaRPr lang="en-US" sz="14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1775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1244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95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2529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144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78359273"/>
                  </a:ext>
                </a:extLst>
              </a:tr>
              <a:tr h="256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48</a:t>
                      </a:r>
                      <a:r>
                        <a:rPr lang="en-US" sz="1400" kern="1200" dirty="0">
                          <a:solidFill>
                            <a:srgbClr val="FF0000"/>
                          </a:solidFill>
                          <a:effectLst/>
                        </a:rPr>
                        <a:t>*</a:t>
                      </a:r>
                      <a:endParaRPr lang="en-US" sz="14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54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387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918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379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94727694"/>
                  </a:ext>
                </a:extLst>
              </a:tr>
              <a:tr h="256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49</a:t>
                      </a:r>
                      <a:r>
                        <a:rPr lang="en-US" sz="1400" kern="1200" dirty="0">
                          <a:solidFill>
                            <a:srgbClr val="FF0000"/>
                          </a:solidFill>
                          <a:effectLst/>
                        </a:rPr>
                        <a:t>*</a:t>
                      </a:r>
                      <a:endParaRPr lang="en-US" sz="1400" kern="100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0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133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579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</a:rPr>
                        <a:t>347</a:t>
                      </a:r>
                      <a:endParaRPr lang="en-US" sz="14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274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</a:rPr>
                        <a:t>0</a:t>
                      </a:r>
                      <a:endParaRPr lang="en-US" sz="14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32038232"/>
                  </a:ext>
                </a:extLst>
              </a:tr>
              <a:tr h="2563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dirty="0">
                          <a:effectLst/>
                        </a:rPr>
                        <a:t>Average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8676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688.5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297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1096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32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kern="1200" cap="all" dirty="0">
                          <a:solidFill>
                            <a:srgbClr val="000000"/>
                          </a:solidFill>
                          <a:effectLst/>
                        </a:rPr>
                        <a:t>0</a:t>
                      </a:r>
                      <a:endParaRPr lang="en-US" sz="1400" b="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78140212"/>
                  </a:ext>
                </a:extLst>
              </a:tr>
            </a:tbl>
          </a:graphicData>
        </a:graphic>
      </p:graphicFrame>
      <p:sp>
        <p:nvSpPr>
          <p:cNvPr id="5" name="Rectangle 2">
            <a:extLst>
              <a:ext uri="{FF2B5EF4-FFF2-40B4-BE49-F238E27FC236}">
                <a16:creationId xmlns:a16="http://schemas.microsoft.com/office/drawing/2014/main" id="{EA731926-EB5D-7177-0DE5-1C1DA6F96D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797" y="236221"/>
            <a:ext cx="11280406" cy="12003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Table S2A. 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asal virus shedding following primary (Day 0) and booster immunization (Day 29) in sheep determined by qPCR. (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imals that received a booster on day 29). </a:t>
            </a:r>
            <a:r>
              <a:rPr lang="en-US" alt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v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– BoHV-1qmv vector control group; </a:t>
            </a:r>
            <a:r>
              <a:rPr kumimoji="0" lang="en-US" altLang="en-US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mv</a:t>
            </a:r>
            <a:r>
              <a:rPr kumimoji="0" lang="en-US" altLang="en-US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ub-RVFV – BoHV-1qmv Sub-RVFV vaccine group.</a:t>
            </a:r>
            <a:endParaRPr kumimoji="0" lang="en-US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20459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9700231"/>
              </p:ext>
            </p:extLst>
          </p:nvPr>
        </p:nvGraphicFramePr>
        <p:xfrm>
          <a:off x="716038" y="1424483"/>
          <a:ext cx="10363199" cy="500212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9576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0351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5154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5154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5154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0236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0236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0236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07178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290628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cap="all" dirty="0">
                          <a:effectLst/>
                        </a:rPr>
                        <a:t>GROUP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Animal </a:t>
                      </a:r>
                      <a:r>
                        <a:rPr lang="en-US" sz="1200" b="1" kern="1200" cap="all" dirty="0">
                          <a:effectLst/>
                        </a:rPr>
                        <a:t>#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 gridSpan="9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Nasal virus shedding following primary (day 0) and booster immunization (day 29) - PFU/nasal swab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421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>
                          <a:effectLst/>
                        </a:rPr>
                        <a:t>Day 0</a:t>
                      </a:r>
                      <a:endParaRPr lang="en-US" sz="1300" b="1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>
                          <a:effectLst/>
                        </a:rPr>
                        <a:t>Day 3</a:t>
                      </a:r>
                      <a:endParaRPr lang="en-US" sz="1300" b="1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>
                          <a:effectLst/>
                        </a:rPr>
                        <a:t>Day 6</a:t>
                      </a:r>
                      <a:endParaRPr lang="en-US" sz="1300" b="1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>
                          <a:effectLst/>
                        </a:rPr>
                        <a:t>Day 7</a:t>
                      </a:r>
                      <a:endParaRPr lang="en-US" sz="1300" b="1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Day 14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>
                          <a:effectLst/>
                        </a:rPr>
                        <a:t>Day 21</a:t>
                      </a:r>
                      <a:endParaRPr lang="en-US" sz="1300" b="1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Day 29       (Day 0 </a:t>
                      </a:r>
                      <a:r>
                        <a:rPr lang="en-US" sz="1200" b="1" kern="1200" dirty="0" err="1">
                          <a:effectLst/>
                        </a:rPr>
                        <a:t>dpb</a:t>
                      </a:r>
                      <a:r>
                        <a:rPr lang="en-US" sz="1200" b="1" kern="1200" dirty="0">
                          <a:effectLst/>
                        </a:rPr>
                        <a:t>)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Day 32     (Day 3 </a:t>
                      </a:r>
                      <a:r>
                        <a:rPr lang="en-US" sz="1200" b="1" kern="1200" dirty="0" err="1">
                          <a:effectLst/>
                        </a:rPr>
                        <a:t>dpb</a:t>
                      </a:r>
                      <a:r>
                        <a:rPr lang="en-US" sz="1200" b="1" kern="1200" dirty="0">
                          <a:effectLst/>
                        </a:rPr>
                        <a:t>)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Day 36   (Day 7 </a:t>
                      </a:r>
                      <a:r>
                        <a:rPr lang="en-US" sz="1200" b="1" kern="1200" dirty="0" err="1">
                          <a:effectLst/>
                        </a:rPr>
                        <a:t>dpb</a:t>
                      </a:r>
                      <a:r>
                        <a:rPr lang="en-US" sz="1200" b="1" kern="1200" dirty="0">
                          <a:effectLst/>
                        </a:rPr>
                        <a:t>)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0628">
                <a:tc rowSpan="6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 err="1">
                          <a:effectLst/>
                        </a:rPr>
                        <a:t>qmv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41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1.0x10</a:t>
                      </a:r>
                      <a:r>
                        <a:rPr lang="en-US" sz="1200" kern="1200" baseline="30000">
                          <a:effectLst/>
                        </a:rPr>
                        <a:t>2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85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42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0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43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5.0x10</a:t>
                      </a:r>
                      <a:r>
                        <a:rPr lang="en-US" sz="1200" kern="1200" baseline="30000">
                          <a:effectLst/>
                        </a:rPr>
                        <a:t>1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1.5x10</a:t>
                      </a:r>
                      <a:r>
                        <a:rPr lang="en-US" sz="1200" kern="1200" baseline="30000">
                          <a:effectLst/>
                        </a:rPr>
                        <a:t>2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85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44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85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5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90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Average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3.0x10</a:t>
                      </a:r>
                      <a:r>
                        <a:rPr lang="en-US" sz="1200" b="1" kern="1200" baseline="30000" dirty="0">
                          <a:effectLst/>
                        </a:rPr>
                        <a:t>1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3.0x10</a:t>
                      </a:r>
                      <a:r>
                        <a:rPr lang="en-US" sz="1200" b="1" kern="1200" baseline="30000" dirty="0">
                          <a:effectLst/>
                        </a:rPr>
                        <a:t>1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90628">
                <a:tc rowSpan="6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Prime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36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2.0x10</a:t>
                      </a:r>
                      <a:r>
                        <a:rPr lang="en-US" sz="1200" kern="1200" baseline="30000">
                          <a:effectLst/>
                        </a:rPr>
                        <a:t>2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85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37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85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38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90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39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1.5x10</a:t>
                      </a:r>
                      <a:r>
                        <a:rPr lang="en-US" sz="1200" kern="1200" baseline="30000">
                          <a:effectLst/>
                        </a:rPr>
                        <a:t>2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90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4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1.0x10</a:t>
                      </a:r>
                      <a:r>
                        <a:rPr lang="en-US" sz="1200" kern="1200" baseline="30000">
                          <a:effectLst/>
                        </a:rPr>
                        <a:t>2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90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Average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5.0x10</a:t>
                      </a:r>
                      <a:r>
                        <a:rPr lang="en-US" sz="1200" b="1" kern="1200" baseline="30000" dirty="0">
                          <a:effectLst/>
                        </a:rPr>
                        <a:t>1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4.0x10</a:t>
                      </a:r>
                      <a:r>
                        <a:rPr lang="en-US" sz="1200" b="1" kern="1200" baseline="30000" dirty="0">
                          <a:effectLst/>
                        </a:rPr>
                        <a:t>1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03200">
                <a:tc rowSpan="6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Prime-Boost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45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endParaRPr lang="en-US" sz="1300" kern="100"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90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46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5.0x10</a:t>
                      </a:r>
                      <a:r>
                        <a:rPr lang="en-US" sz="1200" kern="1200" baseline="30000">
                          <a:effectLst/>
                        </a:rPr>
                        <a:t>1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1.0x10</a:t>
                      </a:r>
                      <a:r>
                        <a:rPr lang="en-US" sz="1200" kern="1200" baseline="30000">
                          <a:effectLst/>
                        </a:rPr>
                        <a:t>2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1.0x10</a:t>
                      </a:r>
                      <a:r>
                        <a:rPr lang="en-US" sz="1200" kern="1200" baseline="30000">
                          <a:effectLst/>
                        </a:rPr>
                        <a:t>2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85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47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1.0x10</a:t>
                      </a:r>
                      <a:r>
                        <a:rPr lang="en-US" sz="1200" kern="1200" baseline="30000">
                          <a:effectLst/>
                        </a:rPr>
                        <a:t>2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85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48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85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49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>
                          <a:effectLst/>
                        </a:rPr>
                        <a:t>0</a:t>
                      </a:r>
                      <a:endParaRPr lang="en-US" sz="1300" kern="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kern="1200" dirty="0">
                          <a:effectLst/>
                        </a:rPr>
                        <a:t>0</a:t>
                      </a:r>
                      <a:endParaRPr lang="en-US" sz="1300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906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Average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1.0x10</a:t>
                      </a:r>
                      <a:r>
                        <a:rPr lang="en-US" sz="1200" b="1" kern="1200" baseline="30000" dirty="0">
                          <a:effectLst/>
                        </a:rPr>
                        <a:t>1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2.0x10</a:t>
                      </a:r>
                      <a:r>
                        <a:rPr lang="en-US" sz="1200" b="1" kern="1200" baseline="30000" dirty="0">
                          <a:effectLst/>
                        </a:rPr>
                        <a:t>1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5.0x10</a:t>
                      </a:r>
                      <a:r>
                        <a:rPr lang="en-US" sz="1200" b="1" kern="1200" baseline="30000" dirty="0">
                          <a:effectLst/>
                        </a:rPr>
                        <a:t>1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kern="1200" dirty="0">
                          <a:effectLst/>
                        </a:rPr>
                        <a:t>0</a:t>
                      </a:r>
                      <a:endParaRPr lang="en-US" sz="1300" b="1" kern="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7909" marR="67909" marT="0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208038" y="207484"/>
            <a:ext cx="118872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2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asal virus shedding following primary (Day 0) and booster immunization (Day 29) in sheep determined by the virus isolation. PFU – Plaque-forming units;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day post-booster.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mv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BoHV-1qmv vector control group; Prime – BoHV-1qmv Sub-RVFV vaccine group received only primary immunization; Prime-Boost– BoHV-1qmv Sub-RVFV vaccine group received both primary and secondary immunization.</a:t>
            </a:r>
          </a:p>
        </p:txBody>
      </p:sp>
    </p:spTree>
    <p:extLst>
      <p:ext uri="{BB962C8B-B14F-4D97-AF65-F5344CB8AC3E}">
        <p14:creationId xmlns:p14="http://schemas.microsoft.com/office/powerpoint/2010/main" val="6586556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2017303E-4172-A3D4-3A4F-89A4889510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8460870"/>
              </p:ext>
            </p:extLst>
          </p:nvPr>
        </p:nvGraphicFramePr>
        <p:xfrm>
          <a:off x="725864" y="1056794"/>
          <a:ext cx="10878530" cy="540448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62361">
                  <a:extLst>
                    <a:ext uri="{9D8B030D-6E8A-4147-A177-3AD203B41FA5}">
                      <a16:colId xmlns:a16="http://schemas.microsoft.com/office/drawing/2014/main" val="1450642988"/>
                    </a:ext>
                  </a:extLst>
                </a:gridCol>
                <a:gridCol w="1497858">
                  <a:extLst>
                    <a:ext uri="{9D8B030D-6E8A-4147-A177-3AD203B41FA5}">
                      <a16:colId xmlns:a16="http://schemas.microsoft.com/office/drawing/2014/main" val="3852642148"/>
                    </a:ext>
                  </a:extLst>
                </a:gridCol>
                <a:gridCol w="1048380">
                  <a:extLst>
                    <a:ext uri="{9D8B030D-6E8A-4147-A177-3AD203B41FA5}">
                      <a16:colId xmlns:a16="http://schemas.microsoft.com/office/drawing/2014/main" val="407450303"/>
                    </a:ext>
                  </a:extLst>
                </a:gridCol>
                <a:gridCol w="1021485">
                  <a:extLst>
                    <a:ext uri="{9D8B030D-6E8A-4147-A177-3AD203B41FA5}">
                      <a16:colId xmlns:a16="http://schemas.microsoft.com/office/drawing/2014/main" val="2786387200"/>
                    </a:ext>
                  </a:extLst>
                </a:gridCol>
                <a:gridCol w="987052">
                  <a:extLst>
                    <a:ext uri="{9D8B030D-6E8A-4147-A177-3AD203B41FA5}">
                      <a16:colId xmlns:a16="http://schemas.microsoft.com/office/drawing/2014/main" val="3550360780"/>
                    </a:ext>
                  </a:extLst>
                </a:gridCol>
                <a:gridCol w="1090348">
                  <a:extLst>
                    <a:ext uri="{9D8B030D-6E8A-4147-A177-3AD203B41FA5}">
                      <a16:colId xmlns:a16="http://schemas.microsoft.com/office/drawing/2014/main" val="3780711953"/>
                    </a:ext>
                  </a:extLst>
                </a:gridCol>
                <a:gridCol w="1055917">
                  <a:extLst>
                    <a:ext uri="{9D8B030D-6E8A-4147-A177-3AD203B41FA5}">
                      <a16:colId xmlns:a16="http://schemas.microsoft.com/office/drawing/2014/main" val="513503616"/>
                    </a:ext>
                  </a:extLst>
                </a:gridCol>
                <a:gridCol w="1147735">
                  <a:extLst>
                    <a:ext uri="{9D8B030D-6E8A-4147-A177-3AD203B41FA5}">
                      <a16:colId xmlns:a16="http://schemas.microsoft.com/office/drawing/2014/main" val="3153477327"/>
                    </a:ext>
                  </a:extLst>
                </a:gridCol>
                <a:gridCol w="1067394">
                  <a:extLst>
                    <a:ext uri="{9D8B030D-6E8A-4147-A177-3AD203B41FA5}">
                      <a16:colId xmlns:a16="http://schemas.microsoft.com/office/drawing/2014/main" val="906892512"/>
                    </a:ext>
                  </a:extLst>
                </a:gridCol>
              </a:tblGrid>
              <a:tr h="18542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Group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Animal #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BoHV-1-specific neutralizing antibody titer in sheep serum  (Days post-vaccinatio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9048468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Day 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Day 7</a:t>
                      </a:r>
                    </a:p>
                  </a:txBody>
                  <a:tcPr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Day 14</a:t>
                      </a:r>
                    </a:p>
                  </a:txBody>
                  <a:tcPr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Day 21</a:t>
                      </a:r>
                    </a:p>
                  </a:txBody>
                  <a:tcPr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Day 29*</a:t>
                      </a:r>
                    </a:p>
                  </a:txBody>
                  <a:tcPr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Day 36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Day 4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7998960"/>
                  </a:ext>
                </a:extLst>
              </a:tr>
              <a:tr h="137183">
                <a:tc rowSpan="6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err="1">
                          <a:effectLst/>
                          <a:latin typeface="+mn-lt"/>
                        </a:rPr>
                        <a:t>qmv</a:t>
                      </a:r>
                      <a:endParaRPr lang="en-US" sz="1200" b="1" dirty="0">
                        <a:effectLst/>
                        <a:latin typeface="+mn-lt"/>
                      </a:endParaRPr>
                    </a:p>
                    <a:p>
                      <a:pPr algn="ctr"/>
                      <a:endParaRPr lang="en-US" sz="1200" dirty="0">
                        <a:latin typeface="+mn-lt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41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4.2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4.08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97.20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6.21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2.34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2.7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85824271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4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4.0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1.0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8.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4.3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2.45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1.2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08741030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4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7.0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8.2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89.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8.5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4.77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1.2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01851234"/>
                  </a:ext>
                </a:extLst>
              </a:tr>
              <a:tr h="144734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4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6.0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9.9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5.6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2.8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8.11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7.8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91150907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50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32.01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5.10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64.22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4.76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0.56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8.9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7062902"/>
                  </a:ext>
                </a:extLst>
              </a:tr>
              <a:tr h="225081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Average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4.68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.68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4.91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1.33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.65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.4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2035162"/>
                  </a:ext>
                </a:extLst>
              </a:tr>
              <a:tr h="0">
                <a:tc rowSpan="6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effectLst/>
                          <a:latin typeface="+mn-lt"/>
                        </a:rPr>
                        <a:t>Prime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36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34.2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9.56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62.77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3.59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7.55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8.7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47464604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3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7.7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3.0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8.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0.1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1.64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0.5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38645444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3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2.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7.7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51.4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6.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9.88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8.1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184333069"/>
                  </a:ext>
                </a:extLst>
              </a:tr>
              <a:tr h="264622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3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8.1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1.3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76.3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5.7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4.97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4.0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162797586"/>
                  </a:ext>
                </a:extLst>
              </a:tr>
              <a:tr h="13716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40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6.47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9.02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59.03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3.33</a:t>
                      </a:r>
                    </a:p>
                  </a:txBody>
                  <a:tcPr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2.07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4.2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9692894"/>
                  </a:ext>
                </a:extLst>
              </a:tr>
              <a:tr h="1371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1200" b="1" dirty="0">
                        <a:highlight>
                          <a:srgbClr val="C0C0C0"/>
                        </a:highlight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highlight>
                          <a:srgbClr val="C0C0C0"/>
                        </a:highlight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C0C0C0"/>
                        </a:highlight>
                        <a:latin typeface="+mn-lt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C0C0C0"/>
                        </a:highlight>
                        <a:latin typeface="+mn-lt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C0C0C0"/>
                        </a:highlight>
                        <a:latin typeface="+mn-lt"/>
                      </a:endParaRPr>
                    </a:p>
                  </a:txBody>
                  <a:tcPr marL="9525" marR="9525" marT="9525" marB="0" anchor="ctr"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verage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.2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.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1127754"/>
                  </a:ext>
                </a:extLst>
              </a:tr>
              <a:tr h="0">
                <a:tc rowSpan="6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effectLst/>
                          <a:latin typeface="+mn-lt"/>
                        </a:rPr>
                        <a:t>Prime-Boost</a:t>
                      </a:r>
                    </a:p>
                    <a:p>
                      <a:pPr algn="ctr"/>
                      <a:endParaRPr lang="en-US" sz="1200" dirty="0">
                        <a:latin typeface="+mn-lt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45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5.29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1.56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64.73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5.5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68.13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66.1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612343997"/>
                  </a:ext>
                </a:extLst>
              </a:tr>
              <a:tr h="163484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4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33.4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9.8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78.5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1.4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31.39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98.6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702151975"/>
                  </a:ext>
                </a:extLst>
              </a:tr>
              <a:tr h="129771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4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36.3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3.1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65.4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0.3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55.17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72.7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95578336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4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9.0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4.9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1.8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7.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12.65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09.6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14249812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+mn-lt"/>
                        </a:rPr>
                        <a:t>49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5.18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2.36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91.55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2.45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12.87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56.8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576747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Average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4.8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1.26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1.99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.58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1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0.8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2823643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8DCBCACD-3E7F-F7D0-91DE-1C60566EF600}"/>
              </a:ext>
            </a:extLst>
          </p:cNvPr>
          <p:cNvSpPr txBox="1"/>
          <p:nvPr/>
        </p:nvSpPr>
        <p:spPr>
          <a:xfrm>
            <a:off x="179294" y="92610"/>
            <a:ext cx="1165226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3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oHV-1-specific neutralizing antibody titer in serum collected from sheep.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mv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BoHV-1qmv vector control group; Prime – BoHV-1qmv Sub-RVFV vaccine group received only primary immunization; Prime-Boost– BoHV-1qmv Sub-RVFV vaccine group received both primary and secondary immunization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7A4747F-C264-72E7-3D33-4D3600E68E8F}"/>
              </a:ext>
            </a:extLst>
          </p:cNvPr>
          <p:cNvSpPr txBox="1"/>
          <p:nvPr/>
        </p:nvSpPr>
        <p:spPr>
          <a:xfrm>
            <a:off x="3758184" y="6569875"/>
            <a:ext cx="34131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ooster immunization performed on day 29 post-vaccination</a:t>
            </a:r>
          </a:p>
        </p:txBody>
      </p:sp>
    </p:spTree>
    <p:extLst>
      <p:ext uri="{BB962C8B-B14F-4D97-AF65-F5344CB8AC3E}">
        <p14:creationId xmlns:p14="http://schemas.microsoft.com/office/powerpoint/2010/main" val="11993567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28CD937-B066-7962-DE17-22825E8250D6}"/>
              </a:ext>
            </a:extLst>
          </p:cNvPr>
          <p:cNvSpPr txBox="1"/>
          <p:nvPr/>
        </p:nvSpPr>
        <p:spPr>
          <a:xfrm>
            <a:off x="233082" y="44475"/>
            <a:ext cx="1177962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4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VFV-specific neutralizing antibody titer in serum collected from sheep.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mv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– BoHV-1qmv vector control group; Prime – BoHV-1qmv Sub-RVFV vaccine group received only primary immunization; Prime-Boost– BoHV-1qmv Sub-RVFV vaccine group received both primary and secondary immunization. 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2A456D8-041F-4F7D-1693-7FA5100A9A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219811"/>
              </p:ext>
            </p:extLst>
          </p:nvPr>
        </p:nvGraphicFramePr>
        <p:xfrm>
          <a:off x="499620" y="960377"/>
          <a:ext cx="10966514" cy="548622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33166">
                  <a:extLst>
                    <a:ext uri="{9D8B030D-6E8A-4147-A177-3AD203B41FA5}">
                      <a16:colId xmlns:a16="http://schemas.microsoft.com/office/drawing/2014/main" val="1450642988"/>
                    </a:ext>
                  </a:extLst>
                </a:gridCol>
                <a:gridCol w="1475574">
                  <a:extLst>
                    <a:ext uri="{9D8B030D-6E8A-4147-A177-3AD203B41FA5}">
                      <a16:colId xmlns:a16="http://schemas.microsoft.com/office/drawing/2014/main" val="3852642148"/>
                    </a:ext>
                  </a:extLst>
                </a:gridCol>
                <a:gridCol w="1074737">
                  <a:extLst>
                    <a:ext uri="{9D8B030D-6E8A-4147-A177-3AD203B41FA5}">
                      <a16:colId xmlns:a16="http://schemas.microsoft.com/office/drawing/2014/main" val="407450303"/>
                    </a:ext>
                  </a:extLst>
                </a:gridCol>
                <a:gridCol w="1141966">
                  <a:extLst>
                    <a:ext uri="{9D8B030D-6E8A-4147-A177-3AD203B41FA5}">
                      <a16:colId xmlns:a16="http://schemas.microsoft.com/office/drawing/2014/main" val="2786387200"/>
                    </a:ext>
                  </a:extLst>
                </a:gridCol>
                <a:gridCol w="1094384">
                  <a:extLst>
                    <a:ext uri="{9D8B030D-6E8A-4147-A177-3AD203B41FA5}">
                      <a16:colId xmlns:a16="http://schemas.microsoft.com/office/drawing/2014/main" val="3550360780"/>
                    </a:ext>
                  </a:extLst>
                </a:gridCol>
                <a:gridCol w="1106280">
                  <a:extLst>
                    <a:ext uri="{9D8B030D-6E8A-4147-A177-3AD203B41FA5}">
                      <a16:colId xmlns:a16="http://schemas.microsoft.com/office/drawing/2014/main" val="3780711953"/>
                    </a:ext>
                  </a:extLst>
                </a:gridCol>
                <a:gridCol w="1046803">
                  <a:extLst>
                    <a:ext uri="{9D8B030D-6E8A-4147-A177-3AD203B41FA5}">
                      <a16:colId xmlns:a16="http://schemas.microsoft.com/office/drawing/2014/main" val="2917022741"/>
                    </a:ext>
                  </a:extLst>
                </a:gridCol>
                <a:gridCol w="1070593">
                  <a:extLst>
                    <a:ext uri="{9D8B030D-6E8A-4147-A177-3AD203B41FA5}">
                      <a16:colId xmlns:a16="http://schemas.microsoft.com/office/drawing/2014/main" val="1035826053"/>
                    </a:ext>
                  </a:extLst>
                </a:gridCol>
                <a:gridCol w="1023011">
                  <a:extLst>
                    <a:ext uri="{9D8B030D-6E8A-4147-A177-3AD203B41FA5}">
                      <a16:colId xmlns:a16="http://schemas.microsoft.com/office/drawing/2014/main" val="3153477327"/>
                    </a:ext>
                  </a:extLst>
                </a:gridCol>
              </a:tblGrid>
              <a:tr h="18542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Group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Animal #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RVFV MP12-specific neutralizing antibody titer in sheep serum  (Days post-vaccination)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9048468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Day 0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Day 7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Day 1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Day 21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Day 29*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Day 36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Day 45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7998960"/>
                  </a:ext>
                </a:extLst>
              </a:tr>
              <a:tr h="229462">
                <a:tc rowSpan="6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 err="1">
                          <a:effectLst/>
                          <a:latin typeface="+mn-lt"/>
                        </a:rPr>
                        <a:t>qmv</a:t>
                      </a:r>
                      <a:endParaRPr lang="en-US" sz="1200" b="1" dirty="0">
                        <a:effectLst/>
                        <a:latin typeface="+mn-lt"/>
                      </a:endParaRPr>
                    </a:p>
                    <a:p>
                      <a:pPr algn="ctr"/>
                      <a:endParaRPr lang="en-US" sz="1200" b="1" dirty="0">
                        <a:latin typeface="+mn-lt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1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85824271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087410307"/>
                  </a:ext>
                </a:extLst>
              </a:tr>
              <a:tr h="26510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0185123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91150907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50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706290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Average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2035162"/>
                  </a:ext>
                </a:extLst>
              </a:tr>
              <a:tr h="0">
                <a:tc rowSpan="6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effectLst/>
                          <a:latin typeface="+mn-lt"/>
                        </a:rPr>
                        <a:t>Prime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6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4.77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5.23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6.03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3.22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0.02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9.57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474646042"/>
                  </a:ext>
                </a:extLst>
              </a:tr>
              <a:tr h="33204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.2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5.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4.3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9.8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7.3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7.11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386454442"/>
                  </a:ext>
                </a:extLst>
              </a:tr>
              <a:tr h="298335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5.7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9.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1.6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0.1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2.5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2.78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184333069"/>
                  </a:ext>
                </a:extLst>
              </a:tr>
              <a:tr h="264622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1.1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6.9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5.0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6.7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8.5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7.69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16279758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0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3.6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8.08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7.2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8.86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0.15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9.89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9692894"/>
                  </a:ext>
                </a:extLst>
              </a:tr>
              <a:tr h="1371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verage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.72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.41</a:t>
                      </a:r>
                    </a:p>
                  </a:txBody>
                  <a:tcPr marL="9525" marR="9525" marT="9525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312645"/>
                  </a:ext>
                </a:extLst>
              </a:tr>
              <a:tr h="274320">
                <a:tc rowSpan="6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effectLst/>
                          <a:latin typeface="+mn-lt"/>
                        </a:rPr>
                        <a:t>Prime-Boost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5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0.23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8.99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6.4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8.46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64.19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52.66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612343997"/>
                  </a:ext>
                </a:extLst>
              </a:tr>
              <a:tr h="163484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13.4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7.4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8.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3.7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55.1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58.79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702151975"/>
                  </a:ext>
                </a:extLst>
              </a:tr>
              <a:tr h="129771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5.1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7.7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6.7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1.8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71.4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64.66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95578336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.7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8.0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31.1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24.8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86.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70.42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14249812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49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8.17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1.91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9.22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12.92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77.17</a:t>
                      </a:r>
                    </a:p>
                  </a:txBody>
                  <a:tcPr anchor="ctr"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68.53</a:t>
                      </a: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576747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+mn-lt"/>
                        </a:rPr>
                        <a:t>Average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latin typeface="+mn-lt"/>
                        </a:rPr>
                        <a:t>˂4</a:t>
                      </a:r>
                    </a:p>
                  </a:txBody>
                  <a:tcPr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13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.09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.61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7.15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4.65</a:t>
                      </a:r>
                    </a:p>
                  </a:txBody>
                  <a:tcPr marL="9525" marR="9525" marT="9525" marB="0" anchor="ctr"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3.01</a:t>
                      </a:r>
                    </a:p>
                  </a:txBody>
                  <a:tcPr marL="9525" marR="9525" marT="9525" marB="0"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2823643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4FB3542-F44D-84BB-72FB-4E4210EE7632}"/>
              </a:ext>
            </a:extLst>
          </p:cNvPr>
          <p:cNvSpPr txBox="1"/>
          <p:nvPr/>
        </p:nvSpPr>
        <p:spPr>
          <a:xfrm>
            <a:off x="3758184" y="6551946"/>
            <a:ext cx="34131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ooster immunization performed on day 29 post-vaccination</a:t>
            </a:r>
          </a:p>
        </p:txBody>
      </p:sp>
    </p:spTree>
    <p:extLst>
      <p:ext uri="{BB962C8B-B14F-4D97-AF65-F5344CB8AC3E}">
        <p14:creationId xmlns:p14="http://schemas.microsoft.com/office/powerpoint/2010/main" val="26214773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8569E8F-EB24-5188-949A-B8BCF6F5C0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4132401"/>
              </p:ext>
            </p:extLst>
          </p:nvPr>
        </p:nvGraphicFramePr>
        <p:xfrm>
          <a:off x="707010" y="1485328"/>
          <a:ext cx="10633436" cy="5041239"/>
        </p:xfrm>
        <a:graphic>
          <a:graphicData uri="http://schemas.openxmlformats.org/drawingml/2006/table">
            <a:tbl>
              <a:tblPr firstRow="1" firstCol="1" bandRow="1">
                <a:tableStyleId>{93296810-A885-4BE3-A3E7-6D5BEEA58F35}</a:tableStyleId>
              </a:tblPr>
              <a:tblGrid>
                <a:gridCol w="2060044">
                  <a:extLst>
                    <a:ext uri="{9D8B030D-6E8A-4147-A177-3AD203B41FA5}">
                      <a16:colId xmlns:a16="http://schemas.microsoft.com/office/drawing/2014/main" val="3889935743"/>
                    </a:ext>
                  </a:extLst>
                </a:gridCol>
                <a:gridCol w="1343862">
                  <a:extLst>
                    <a:ext uri="{9D8B030D-6E8A-4147-A177-3AD203B41FA5}">
                      <a16:colId xmlns:a16="http://schemas.microsoft.com/office/drawing/2014/main" val="4141874970"/>
                    </a:ext>
                  </a:extLst>
                </a:gridCol>
                <a:gridCol w="2471191">
                  <a:extLst>
                    <a:ext uri="{9D8B030D-6E8A-4147-A177-3AD203B41FA5}">
                      <a16:colId xmlns:a16="http://schemas.microsoft.com/office/drawing/2014/main" val="3337584175"/>
                    </a:ext>
                  </a:extLst>
                </a:gridCol>
                <a:gridCol w="2354891">
                  <a:extLst>
                    <a:ext uri="{9D8B030D-6E8A-4147-A177-3AD203B41FA5}">
                      <a16:colId xmlns:a16="http://schemas.microsoft.com/office/drawing/2014/main" val="3481618053"/>
                    </a:ext>
                  </a:extLst>
                </a:gridCol>
                <a:gridCol w="2403448">
                  <a:extLst>
                    <a:ext uri="{9D8B030D-6E8A-4147-A177-3AD203B41FA5}">
                      <a16:colId xmlns:a16="http://schemas.microsoft.com/office/drawing/2014/main" val="1836263839"/>
                    </a:ext>
                  </a:extLst>
                </a:gridCol>
              </a:tblGrid>
              <a:tr h="510346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up</a:t>
                      </a:r>
                    </a:p>
                  </a:txBody>
                  <a:tcPr marL="68580" marR="68580" marT="9525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#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d-change in IFN-gamma mRNA expression after PBMC stimulation (Days post-vaccination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23892238"/>
                  </a:ext>
                </a:extLst>
              </a:tr>
              <a:tr h="3160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0</a:t>
                      </a:r>
                      <a:endParaRPr lang="en-US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14</a:t>
                      </a:r>
                      <a:endParaRPr lang="en-US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21</a:t>
                      </a:r>
                      <a:endParaRPr lang="en-US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460597038"/>
                  </a:ext>
                </a:extLst>
              </a:tr>
              <a:tr h="296760">
                <a:tc rowSpan="6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mv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793907177"/>
                  </a:ext>
                </a:extLst>
              </a:tr>
              <a:tr h="234892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</a:t>
                      </a: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1281315371"/>
                  </a:ext>
                </a:extLst>
              </a:tr>
              <a:tr h="171354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</a:t>
                      </a: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558247944"/>
                  </a:ext>
                </a:extLst>
              </a:tr>
              <a:tr h="2838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2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</a:t>
                      </a: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1523663198"/>
                  </a:ext>
                </a:extLst>
              </a:tr>
              <a:tr h="1419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</a:t>
                      </a: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</a:t>
                      </a: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408200690"/>
                  </a:ext>
                </a:extLst>
              </a:tr>
              <a:tr h="1419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8580" marR="68580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2369693"/>
                  </a:ext>
                </a:extLst>
              </a:tr>
              <a:tr h="290005">
                <a:tc rowSpan="1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mv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ub-RVFV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5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754799983"/>
                  </a:ext>
                </a:extLst>
              </a:tr>
              <a:tr h="290006"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905157124"/>
                  </a:ext>
                </a:extLst>
              </a:tr>
              <a:tr h="313596"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2990833153"/>
                  </a:ext>
                </a:extLst>
              </a:tr>
              <a:tr h="72501"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2990169730"/>
                  </a:ext>
                </a:extLst>
              </a:tr>
              <a:tr h="29000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829228819"/>
                  </a:ext>
                </a:extLst>
              </a:tr>
              <a:tr h="290005"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4095057510"/>
                  </a:ext>
                </a:extLst>
              </a:tr>
              <a:tr h="1450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7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964233881"/>
                  </a:ext>
                </a:extLst>
              </a:tr>
              <a:tr h="290005"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2686953193"/>
                  </a:ext>
                </a:extLst>
              </a:tr>
              <a:tr h="29000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4235164692"/>
                  </a:ext>
                </a:extLst>
              </a:tr>
              <a:tr h="1450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2289823272"/>
                  </a:ext>
                </a:extLst>
              </a:tr>
              <a:tr h="1450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539392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AC8C0E0E-991B-DE9C-5F70-D0354986AB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186" y="167360"/>
            <a:ext cx="11833414" cy="12003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S5: </a:t>
            </a:r>
            <a:r>
              <a:rPr kumimoji="0" lang="en-US" altLang="en-US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-mediated immune response assay </a:t>
            </a:r>
            <a:r>
              <a:rPr lang="en-US" alt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sing PBMCs collected from BoHV-1qmv Sub-RVFV immunized sheep. </a:t>
            </a:r>
            <a:r>
              <a:rPr kumimoji="0" lang="en-US" altLang="en-US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ld-change in IFN-gamma mRNA expression after PBMC stimulation</a:t>
            </a:r>
            <a:r>
              <a:rPr lang="en-US" alt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alt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mv</a:t>
            </a:r>
            <a:r>
              <a:rPr lang="en-US" alt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– BoHV-1qmv vector control group; Prime – BoHV-1qmv Sub-RVFV vaccine group received only primary immunization; Prime-Boost– BoHV-1qmv Sub-RVFV vaccine group received both primary and secondary immunization. </a:t>
            </a:r>
            <a:endParaRPr kumimoji="0" lang="en-US" altLang="en-US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662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4</TotalTime>
  <Words>1528</Words>
  <Application>Microsoft Office PowerPoint</Application>
  <PresentationFormat>Widescreen</PresentationFormat>
  <Paragraphs>99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vulraj Selvaraj</dc:creator>
  <cp:lastModifiedBy>ADMIN</cp:lastModifiedBy>
  <cp:revision>28</cp:revision>
  <dcterms:created xsi:type="dcterms:W3CDTF">2024-08-14T04:57:15Z</dcterms:created>
  <dcterms:modified xsi:type="dcterms:W3CDTF">2024-11-11T18:18:37Z</dcterms:modified>
</cp:coreProperties>
</file>